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25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531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085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3810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585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624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366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2885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723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225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078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307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B9A0D4-A22E-4254-902C-6A0312CCC5A5}" type="datetimeFigureOut">
              <a:rPr lang="en-US" smtClean="0"/>
              <a:t>04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A58AD-783D-4B22-B135-31FB6679F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175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181030" y="212353"/>
            <a:ext cx="11596001" cy="6177430"/>
            <a:chOff x="181030" y="212353"/>
            <a:chExt cx="11596001" cy="6177430"/>
          </a:xfrm>
        </p:grpSpPr>
        <p:sp>
          <p:nvSpPr>
            <p:cNvPr id="5" name="Rectangle 4"/>
            <p:cNvSpPr/>
            <p:nvPr/>
          </p:nvSpPr>
          <p:spPr>
            <a:xfrm>
              <a:off x="572877" y="364319"/>
              <a:ext cx="11204154" cy="602546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81030" y="212353"/>
              <a:ext cx="37378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1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1203966" y="4625301"/>
              <a:ext cx="10336237" cy="7386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400" b="1" dirty="0" smtClean="0">
                  <a:solidFill>
                    <a:srgbClr val="000000"/>
                  </a:solidFill>
                  <a:latin typeface="Cambria" panose="020405030504060302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Supplementary Figure 1. A. </a:t>
              </a:r>
              <a:r>
                <a:rPr lang="en-US" sz="1400" dirty="0" smtClean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RT-qPCR data revealed that miR-429 expression was substantially increased in AGSR-CDDP cells that were transfected by miR-429 mimics than the cells transfected with negative control. </a:t>
              </a:r>
              <a:r>
                <a:rPr lang="en-US" sz="1400" b="1" dirty="0" smtClean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B. </a:t>
              </a:r>
              <a:r>
                <a:rPr lang="en-US" sz="1400" dirty="0" smtClean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A significant decrease in miR-429 expression level in AGS cells transfected with anti-miR-429 than those cells transfected with negative control was detected. </a:t>
              </a:r>
              <a:endParaRPr lang="en-US" sz="1400" dirty="0"/>
            </a:p>
          </p:txBody>
        </p:sp>
        <p:grpSp>
          <p:nvGrpSpPr>
            <p:cNvPr id="23" name="Group 22"/>
            <p:cNvGrpSpPr/>
            <p:nvPr/>
          </p:nvGrpSpPr>
          <p:grpSpPr>
            <a:xfrm>
              <a:off x="2646563" y="1755150"/>
              <a:ext cx="6925833" cy="2179512"/>
              <a:chOff x="2646563" y="1755150"/>
              <a:chExt cx="6925833" cy="2179512"/>
            </a:xfrm>
          </p:grpSpPr>
          <p:grpSp>
            <p:nvGrpSpPr>
              <p:cNvPr id="24" name="Group 23"/>
              <p:cNvGrpSpPr/>
              <p:nvPr/>
            </p:nvGrpSpPr>
            <p:grpSpPr>
              <a:xfrm>
                <a:off x="2646563" y="1755150"/>
                <a:ext cx="3352654" cy="2179512"/>
                <a:chOff x="2646563" y="1755150"/>
                <a:chExt cx="3352654" cy="2179512"/>
              </a:xfrm>
            </p:grpSpPr>
            <p:grpSp>
              <p:nvGrpSpPr>
                <p:cNvPr id="32" name="Group 31"/>
                <p:cNvGrpSpPr/>
                <p:nvPr/>
              </p:nvGrpSpPr>
              <p:grpSpPr>
                <a:xfrm>
                  <a:off x="2646563" y="1755150"/>
                  <a:ext cx="3352654" cy="2179512"/>
                  <a:chOff x="3053646" y="1995782"/>
                  <a:chExt cx="3352654" cy="2179512"/>
                </a:xfrm>
              </p:grpSpPr>
              <p:grpSp>
                <p:nvGrpSpPr>
                  <p:cNvPr id="34" name="Group 33"/>
                  <p:cNvGrpSpPr/>
                  <p:nvPr/>
                </p:nvGrpSpPr>
                <p:grpSpPr>
                  <a:xfrm>
                    <a:off x="3311841" y="2126587"/>
                    <a:ext cx="3094459" cy="2048707"/>
                    <a:chOff x="1019507" y="1021119"/>
                    <a:chExt cx="3094459" cy="2048707"/>
                  </a:xfrm>
                </p:grpSpPr>
                <p:pic>
                  <p:nvPicPr>
                    <p:cNvPr id="36" name="Picture 35"/>
                    <p:cNvPicPr>
                      <a:picLocks noChangeAspect="1"/>
                    </p:cNvPicPr>
                    <p:nvPr/>
                  </p:nvPicPr>
                  <p:blipFill rotWithShape="1">
                    <a:blip r:embed="rId2"/>
                    <a:srcRect b="11605"/>
                    <a:stretch/>
                  </p:blipFill>
                  <p:spPr>
                    <a:xfrm>
                      <a:off x="1019507" y="1021119"/>
                      <a:ext cx="3094459" cy="181787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7" name="TextBox 36"/>
                    <p:cNvSpPr txBox="1"/>
                    <p:nvPr/>
                  </p:nvSpPr>
                  <p:spPr>
                    <a:xfrm>
                      <a:off x="1728194" y="2838994"/>
                      <a:ext cx="90179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SR-CDDP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5" name="TextBox 34"/>
                  <p:cNvSpPr txBox="1"/>
                  <p:nvPr/>
                </p:nvSpPr>
                <p:spPr>
                  <a:xfrm>
                    <a:off x="3053646" y="1995782"/>
                    <a:ext cx="51639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3" name="TextBox 32"/>
                <p:cNvSpPr txBox="1"/>
                <p:nvPr/>
              </p:nvSpPr>
              <p:spPr>
                <a:xfrm>
                  <a:off x="4095111" y="2087039"/>
                  <a:ext cx="49929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***</a:t>
                  </a:r>
                  <a:endParaRPr lang="en-US" sz="1200" dirty="0"/>
                </a:p>
              </p:txBody>
            </p:sp>
          </p:grpSp>
          <p:grpSp>
            <p:nvGrpSpPr>
              <p:cNvPr id="25" name="Group 24"/>
              <p:cNvGrpSpPr/>
              <p:nvPr/>
            </p:nvGrpSpPr>
            <p:grpSpPr>
              <a:xfrm>
                <a:off x="6372085" y="1755150"/>
                <a:ext cx="3200311" cy="2179512"/>
                <a:chOff x="6372085" y="1755150"/>
                <a:chExt cx="3200311" cy="2179512"/>
              </a:xfrm>
            </p:grpSpPr>
            <p:grpSp>
              <p:nvGrpSpPr>
                <p:cNvPr id="26" name="Group 25"/>
                <p:cNvGrpSpPr/>
                <p:nvPr/>
              </p:nvGrpSpPr>
              <p:grpSpPr>
                <a:xfrm>
                  <a:off x="6372085" y="1755150"/>
                  <a:ext cx="3200311" cy="2179512"/>
                  <a:chOff x="6779168" y="1995782"/>
                  <a:chExt cx="3200311" cy="2179512"/>
                </a:xfrm>
              </p:grpSpPr>
              <p:grpSp>
                <p:nvGrpSpPr>
                  <p:cNvPr id="28" name="Group 27"/>
                  <p:cNvGrpSpPr/>
                  <p:nvPr/>
                </p:nvGrpSpPr>
                <p:grpSpPr>
                  <a:xfrm>
                    <a:off x="7037363" y="2126587"/>
                    <a:ext cx="2942116" cy="2048707"/>
                    <a:chOff x="4239932" y="1021119"/>
                    <a:chExt cx="2942116" cy="2048707"/>
                  </a:xfrm>
                </p:grpSpPr>
                <p:pic>
                  <p:nvPicPr>
                    <p:cNvPr id="30" name="Picture 29"/>
                    <p:cNvPicPr>
                      <a:picLocks noChangeAspect="1"/>
                    </p:cNvPicPr>
                    <p:nvPr/>
                  </p:nvPicPr>
                  <p:blipFill rotWithShape="1">
                    <a:blip r:embed="rId3"/>
                    <a:srcRect b="10757"/>
                    <a:stretch/>
                  </p:blipFill>
                  <p:spPr>
                    <a:xfrm>
                      <a:off x="4239932" y="1021119"/>
                      <a:ext cx="2942116" cy="183529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1" name="TextBox 30"/>
                    <p:cNvSpPr txBox="1"/>
                    <p:nvPr/>
                  </p:nvSpPr>
                  <p:spPr>
                    <a:xfrm>
                      <a:off x="5189851" y="2838994"/>
                      <a:ext cx="566515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S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9" name="TextBox 28"/>
                  <p:cNvSpPr txBox="1"/>
                  <p:nvPr/>
                </p:nvSpPr>
                <p:spPr>
                  <a:xfrm>
                    <a:off x="6779168" y="1995782"/>
                    <a:ext cx="51639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  <a:endPara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7" name="TextBox 26"/>
                <p:cNvSpPr txBox="1"/>
                <p:nvPr/>
              </p:nvSpPr>
              <p:spPr>
                <a:xfrm>
                  <a:off x="7803602" y="3104595"/>
                  <a:ext cx="49929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***</a:t>
                  </a:r>
                  <a:endParaRPr lang="en-US" sz="1200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8747551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586" y="222148"/>
            <a:ext cx="37378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4764875" y="1601719"/>
            <a:ext cx="2766762" cy="1941285"/>
            <a:chOff x="5370802" y="1524601"/>
            <a:chExt cx="2766762" cy="1941285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944023" y="2645726"/>
              <a:ext cx="1839051" cy="82016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 rot="18539573">
              <a:off x="6318120" y="2023628"/>
              <a:ext cx="12288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insenoside 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g3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455164" y="2665117"/>
              <a:ext cx="7433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K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8539573">
              <a:off x="5888273" y="2028202"/>
              <a:ext cx="12288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eg. Ctrl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8539573">
              <a:off x="6767859" y="1997952"/>
              <a:ext cx="1228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insenoside 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g3 + anti-miR-429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8539573">
              <a:off x="7338455" y="1987823"/>
              <a:ext cx="1228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insenoside 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g3 + Scramble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370802" y="3185658"/>
              <a:ext cx="7433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Rectangle 10"/>
          <p:cNvSpPr/>
          <p:nvPr/>
        </p:nvSpPr>
        <p:spPr>
          <a:xfrm>
            <a:off x="1856897" y="4518177"/>
            <a:ext cx="887353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sz="1400" b="1" dirty="0" smtClean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insenoside </a:t>
            </a:r>
            <a:r>
              <a:rPr lang="en-US" sz="1400" b="1" dirty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g3 </a:t>
            </a:r>
            <a:r>
              <a:rPr lang="en-US" sz="1400" b="1" dirty="0" smtClean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duced </a:t>
            </a:r>
            <a:r>
              <a:rPr lang="en-US" sz="1400" b="1" dirty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en-US" sz="1400" b="1" dirty="0" smtClean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hosphorylated protein level of AKT in </a:t>
            </a:r>
            <a:r>
              <a:rPr lang="en-US" sz="1400" b="1" dirty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isplatin-resistant GC cells </a:t>
            </a:r>
            <a:r>
              <a:rPr lang="en-US" sz="1400" b="1" dirty="0" smtClean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sibly through </a:t>
            </a:r>
            <a:r>
              <a:rPr lang="en-US" sz="1400" b="1" dirty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iR-429. </a:t>
            </a:r>
            <a:r>
              <a:rPr lang="en-US" sz="1400" dirty="0" smtClean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estern blot analysis revealed that Ginsenoside </a:t>
            </a:r>
            <a:r>
              <a:rPr lang="en-US" sz="1400" dirty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g3 </a:t>
            </a:r>
            <a:r>
              <a:rPr lang="en-US" sz="1400" dirty="0" smtClean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ignificantly decreased the phosphorylated levels </a:t>
            </a:r>
            <a:r>
              <a:rPr lang="en-US" sz="1400" dirty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1400" dirty="0" smtClean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KT. </a:t>
            </a:r>
            <a:r>
              <a:rPr lang="en-US" sz="1400" dirty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owever, the inhibitory effect of Ginsenoside Rg3 was </a:t>
            </a:r>
            <a:r>
              <a:rPr lang="en-US" sz="1400" dirty="0" smtClean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iminished </a:t>
            </a:r>
            <a:r>
              <a:rPr lang="en-US" sz="1400" dirty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fter anti-miR-429 </a:t>
            </a:r>
            <a:r>
              <a:rPr lang="en-US" sz="1400" dirty="0" smtClean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ansfection. </a:t>
            </a:r>
            <a:r>
              <a:rPr lang="en-US" sz="1400" dirty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APDH was used as </a:t>
            </a:r>
            <a:r>
              <a:rPr lang="en-US" sz="1400" dirty="0" smtClean="0">
                <a:latin typeface="Cambria" panose="020405030504060302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oading control.</a:t>
            </a:r>
            <a:endParaRPr lang="en-US" sz="1400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8124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141</Words>
  <Application>Microsoft Office PowerPoint</Application>
  <PresentationFormat>Widescreen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Office Theme</vt:lpstr>
      <vt:lpstr>PowerPoint Presentation</vt:lpstr>
      <vt:lpstr>PowerPoint Presentation</vt:lpstr>
    </vt:vector>
  </TitlesOfParts>
  <Company>Moorche 30 DV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T www.Win2Farsi.com</dc:creator>
  <cp:lastModifiedBy>MRT www.Win2Farsi.com</cp:lastModifiedBy>
  <cp:revision>9</cp:revision>
  <dcterms:created xsi:type="dcterms:W3CDTF">2021-05-30T17:24:13Z</dcterms:created>
  <dcterms:modified xsi:type="dcterms:W3CDTF">2022-01-04T20:04:14Z</dcterms:modified>
</cp:coreProperties>
</file>